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472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707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95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268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834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732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29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400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923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36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633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1E65D-B58E-454C-9636-6622CD9C682F}" type="datetimeFigureOut">
              <a:rPr lang="en-US" smtClean="0"/>
              <a:t>12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70D93-E175-4D5D-874F-21CC59F85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44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jla\Desktop\Analyzed Data\Western Blot\Analysis\Powerpoint\160915 C, TGFB, Ouabain(30nm), T+O\FNSMATUB-high resolution_4mod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3952" y="2516331"/>
            <a:ext cx="2309949" cy="32211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jla\Desktop\Analyzed Data\Western Blot\Analysis\Powerpoint\160915 C, TGFB, Ouabain(30nm), T+O\caveolin-1_15% gel cleaner_9mod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21973" y="2096793"/>
            <a:ext cx="2279631" cy="31881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5" descr="C:\Users\jla\Desktop\Analyzed Data\Western Blot\Analysis\Powerpoint\160915 C, TGFB, Ouabain(30nm), T+O\FNSMATUB take 2_5mod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3951" y="2931329"/>
            <a:ext cx="2279631" cy="3452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5" descr="C:\Users\jla\Desktop\Analyzed Data\Western Blot\Analysis\Powerpoint\160915 C, TGFB, Ouabain(30nm), T+O\FNSMATUB take 2_5mod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3951" y="3326342"/>
            <a:ext cx="2293487" cy="29642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1415924" y="3945438"/>
            <a:ext cx="3651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abain (30nM):      -           -            +            +      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02628" y="2528499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718658" y="2999601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M-a-actin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64816" y="3326342"/>
            <a:ext cx="680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007173" y="3668439"/>
            <a:ext cx="3118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l-G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      -           +            -            +        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52600" y="2156790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veolin-1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62941" y="4419600"/>
            <a:ext cx="4804459" cy="1154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 Fig. </a:t>
            </a:r>
            <a:r>
              <a:rPr lang="en-US" sz="12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abain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es not 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 Caveolin-1 expression in 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F.</a:t>
            </a:r>
            <a:endParaRPr lang="en-US" sz="1200" dirty="0"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rum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ved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F were treated with or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out 1 </a:t>
            </a:r>
            <a:r>
              <a:rPr lang="en-US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ml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l-G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/ or 30 </a:t>
            </a:r>
            <a:r>
              <a:rPr lang="en-US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abain for 24 hours. Cells were lysed and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zed by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stern blotting with desired antibodies. </a:t>
            </a:r>
            <a:endParaRPr lang="en-US" sz="1200" dirty="0"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727613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05</TotalTime>
  <Words>69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Chicago Medicine &amp; Biological Scienc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, Jennier [BSD] - MED</dc:creator>
  <cp:lastModifiedBy>Nickolai Dulin</cp:lastModifiedBy>
  <cp:revision>83</cp:revision>
  <cp:lastPrinted>2016-11-17T16:32:06Z</cp:lastPrinted>
  <dcterms:created xsi:type="dcterms:W3CDTF">2016-08-04T17:41:18Z</dcterms:created>
  <dcterms:modified xsi:type="dcterms:W3CDTF">2016-12-08T00:05:40Z</dcterms:modified>
</cp:coreProperties>
</file>